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35" userDrawn="1">
          <p15:clr>
            <a:srgbClr val="A4A3A4"/>
          </p15:clr>
        </p15:guide>
        <p15:guide id="2" pos="4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704" y="108"/>
      </p:cViewPr>
      <p:guideLst>
        <p:guide orient="horz" pos="3135"/>
        <p:guide pos="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e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A51618-DA19-4F2A-9C0B-DEF8C54F24A4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D0CA2A-D991-4103-A2FA-D647766FBED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0118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DC Aktivierung</a:t>
            </a:r>
            <a:r>
              <a:rPr lang="de-DE" baseline="0" dirty="0"/>
              <a:t> Silvestrol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FD0CA2A-D991-4103-A2FA-D647766FBEDA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3216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05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4109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3947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542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4429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583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779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9245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457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579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7354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65EB5-8E1C-4638-A5D0-EF44EC0D64FA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9BBA0-6D80-4A92-B6B9-605A7256EF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4301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wmf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0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3228436"/>
              </p:ext>
            </p:extLst>
          </p:nvPr>
        </p:nvGraphicFramePr>
        <p:xfrm>
          <a:off x="211138" y="15875"/>
          <a:ext cx="2433637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Prism 7" r:id="rId4" imgW="3744360" imgH="2695680" progId="Prism7.Document">
                  <p:embed/>
                </p:oleObj>
              </mc:Choice>
              <mc:Fallback>
                <p:oleObj name="Prism 7" r:id="rId4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1138" y="15875"/>
                        <a:ext cx="2433637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2176510"/>
              </p:ext>
            </p:extLst>
          </p:nvPr>
        </p:nvGraphicFramePr>
        <p:xfrm>
          <a:off x="2495550" y="15875"/>
          <a:ext cx="2438400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7" r:id="rId6" imgW="3749040" imgH="2695680" progId="Prism7.Document">
                  <p:embed/>
                </p:oleObj>
              </mc:Choice>
              <mc:Fallback>
                <p:oleObj name="Prism 7" r:id="rId6" imgW="374904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95550" y="15875"/>
                        <a:ext cx="2438400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1307754"/>
              </p:ext>
            </p:extLst>
          </p:nvPr>
        </p:nvGraphicFramePr>
        <p:xfrm>
          <a:off x="4930775" y="23813"/>
          <a:ext cx="2438400" cy="1751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0" name="Prism 7" r:id="rId8" imgW="3749040" imgH="2695680" progId="Prism7.Document">
                  <p:embed/>
                </p:oleObj>
              </mc:Choice>
              <mc:Fallback>
                <p:oleObj name="Prism 7" r:id="rId8" imgW="374904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930775" y="23813"/>
                        <a:ext cx="2438400" cy="1751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1982852"/>
              </p:ext>
            </p:extLst>
          </p:nvPr>
        </p:nvGraphicFramePr>
        <p:xfrm>
          <a:off x="211138" y="1838325"/>
          <a:ext cx="2433637" cy="1754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1" name="Prism 7" r:id="rId10" imgW="3744360" imgH="2695680" progId="Prism7.Document">
                  <p:embed/>
                </p:oleObj>
              </mc:Choice>
              <mc:Fallback>
                <p:oleObj name="Prism 7" r:id="rId10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1138" y="1838325"/>
                        <a:ext cx="2433637" cy="1754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9729868"/>
              </p:ext>
            </p:extLst>
          </p:nvPr>
        </p:nvGraphicFramePr>
        <p:xfrm>
          <a:off x="2495550" y="1838325"/>
          <a:ext cx="2435225" cy="1754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2" name="Prism 7" r:id="rId12" imgW="3744360" imgH="2695680" progId="Prism7.Document">
                  <p:embed/>
                </p:oleObj>
              </mc:Choice>
              <mc:Fallback>
                <p:oleObj name="Prism 7" r:id="rId12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95550" y="1838325"/>
                        <a:ext cx="2435225" cy="1754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221598"/>
              </p:ext>
            </p:extLst>
          </p:nvPr>
        </p:nvGraphicFramePr>
        <p:xfrm>
          <a:off x="4932363" y="1846263"/>
          <a:ext cx="2433637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" name="Prism 7" r:id="rId14" imgW="3744360" imgH="2695680" progId="Prism7.Document">
                  <p:embed/>
                </p:oleObj>
              </mc:Choice>
              <mc:Fallback>
                <p:oleObj name="Prism 7" r:id="rId14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932363" y="1846263"/>
                        <a:ext cx="2433637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240858"/>
              </p:ext>
            </p:extLst>
          </p:nvPr>
        </p:nvGraphicFramePr>
        <p:xfrm>
          <a:off x="211138" y="3638550"/>
          <a:ext cx="2433637" cy="1751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4" name="Prism 7" r:id="rId16" imgW="3744360" imgH="2695680" progId="Prism7.Document">
                  <p:embed/>
                </p:oleObj>
              </mc:Choice>
              <mc:Fallback>
                <p:oleObj name="Prism 7" r:id="rId16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11138" y="3638550"/>
                        <a:ext cx="2433637" cy="1751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7351798"/>
              </p:ext>
            </p:extLst>
          </p:nvPr>
        </p:nvGraphicFramePr>
        <p:xfrm>
          <a:off x="2495550" y="3638550"/>
          <a:ext cx="2435225" cy="1751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5" name="Prism 7" r:id="rId18" imgW="3744360" imgH="2695680" progId="Prism7.Document">
                  <p:embed/>
                </p:oleObj>
              </mc:Choice>
              <mc:Fallback>
                <p:oleObj name="Prism 7" r:id="rId18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495550" y="3638550"/>
                        <a:ext cx="2435225" cy="1751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588279"/>
              </p:ext>
            </p:extLst>
          </p:nvPr>
        </p:nvGraphicFramePr>
        <p:xfrm>
          <a:off x="4932363" y="3646488"/>
          <a:ext cx="2433637" cy="1751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" name="Prism 7" r:id="rId20" imgW="3744360" imgH="2695680" progId="Prism7.Document">
                  <p:embed/>
                </p:oleObj>
              </mc:Choice>
              <mc:Fallback>
                <p:oleObj name="Prism 7" r:id="rId20" imgW="3744360" imgH="2695680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932363" y="3646488"/>
                        <a:ext cx="2433637" cy="1751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120142" y="5684433"/>
            <a:ext cx="881811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/>
              <a:t>Supplemental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5: </a:t>
            </a:r>
            <a:r>
              <a:rPr lang="en-US" sz="1100" dirty="0"/>
              <a:t>Effect of silvestrol on surface markers (A) and cytokine/chemokine release (B) on activated </a:t>
            </a:r>
            <a:r>
              <a:rPr lang="en-US" sz="1100" dirty="0" err="1"/>
              <a:t>MdDCs</a:t>
            </a:r>
            <a:r>
              <a:rPr lang="en-US" sz="1100" dirty="0"/>
              <a:t>. </a:t>
            </a:r>
            <a:r>
              <a:rPr lang="en-US" sz="1100" dirty="0" err="1"/>
              <a:t>MdDCs</a:t>
            </a:r>
            <a:r>
              <a:rPr lang="en-US" sz="1100" dirty="0"/>
              <a:t> were activated with a mixture of IL-1β, IL-6, TNF-α, PGE</a:t>
            </a:r>
            <a:r>
              <a:rPr lang="en-US" sz="1100" baseline="-25000" dirty="0"/>
              <a:t>2</a:t>
            </a:r>
            <a:r>
              <a:rPr lang="en-US" sz="1100" dirty="0"/>
              <a:t> for 1 day in the presence or absence of different concentrations of </a:t>
            </a:r>
            <a:r>
              <a:rPr lang="en-US" sz="1100" dirty="0" err="1"/>
              <a:t>silvestrol</a:t>
            </a:r>
            <a:r>
              <a:rPr lang="en-US" sz="1100" dirty="0"/>
              <a:t> (0.5, 2.5, 5 </a:t>
            </a:r>
            <a:r>
              <a:rPr lang="en-US" sz="1100" dirty="0" err="1"/>
              <a:t>nM</a:t>
            </a:r>
            <a:r>
              <a:rPr lang="en-US" sz="1100" dirty="0"/>
              <a:t>) or vehicle (DMSO). A) Surface marker expression was measured by </a:t>
            </a:r>
            <a:r>
              <a:rPr lang="en-US" sz="1100" dirty="0" err="1"/>
              <a:t>MACSQuant</a:t>
            </a:r>
            <a:r>
              <a:rPr lang="en-US" sz="1100" dirty="0"/>
              <a:t>® Analyzer 10 in triplicates. Fold induction of the geometric mean of the fluorescence intensity was calculated by referring treated cells to vehicle controls (n=6). B) Released cytokines in the supernatant were measured by cytometric bead array (n=6). For statistical analysis one-way ANOVA with </a:t>
            </a:r>
            <a:r>
              <a:rPr lang="en-US" sz="1100" dirty="0" err="1"/>
              <a:t>Dunnett’s</a:t>
            </a:r>
            <a:r>
              <a:rPr lang="en-US" sz="1100" dirty="0"/>
              <a:t> multiple comparisons test (A) or unpaired t test (B) was used. * p&lt;0.05. ** p&lt;0.01. ***p&lt;0.001</a:t>
            </a:r>
            <a:endParaRPr lang="de-DE" sz="1100" b="1" dirty="0"/>
          </a:p>
        </p:txBody>
      </p:sp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274266"/>
              </p:ext>
            </p:extLst>
          </p:nvPr>
        </p:nvGraphicFramePr>
        <p:xfrm>
          <a:off x="7345266" y="3646293"/>
          <a:ext cx="1798734" cy="17639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" name="Prism 7" r:id="rId22" imgW="2767283" imgH="2713761" progId="Prism7.Document">
                  <p:embed/>
                </p:oleObj>
              </mc:Choice>
              <mc:Fallback>
                <p:oleObj name="Prism 7" r:id="rId22" imgW="2767283" imgH="2713761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7345266" y="3646293"/>
                        <a:ext cx="1798734" cy="17639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/>
          <p:cNvSpPr txBox="1"/>
          <p:nvPr/>
        </p:nvSpPr>
        <p:spPr>
          <a:xfrm>
            <a:off x="48079" y="23745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A)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7154393" y="363552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384172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8</Words>
  <Application>Microsoft Office PowerPoint</Application>
  <PresentationFormat>Bildschirmpräsentation (4:3)</PresentationFormat>
  <Paragraphs>5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onard Blum</dc:creator>
  <cp:lastModifiedBy>Leo</cp:lastModifiedBy>
  <cp:revision>9</cp:revision>
  <cp:lastPrinted>2019-07-22T08:37:17Z</cp:lastPrinted>
  <dcterms:created xsi:type="dcterms:W3CDTF">2019-07-08T08:43:44Z</dcterms:created>
  <dcterms:modified xsi:type="dcterms:W3CDTF">2020-04-27T08:49:31Z</dcterms:modified>
</cp:coreProperties>
</file>